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9" r:id="rId2"/>
    <p:sldId id="260" r:id="rId3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A336E61-CEB3-3249-FD39-D222D0E0797F}" v="41" dt="2024-01-24T20:56:47.625"/>
    <p1510:client id="{BCF0CDA2-F36C-63AD-96C7-A4D01E0829BA}" v="32" dt="2024-01-24T15:25:09.05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6327"/>
  </p:normalViewPr>
  <p:slideViewPr>
    <p:cSldViewPr snapToGrid="0">
      <p:cViewPr varScale="1">
        <p:scale>
          <a:sx n="84" d="100"/>
          <a:sy n="84" d="100"/>
        </p:scale>
        <p:origin x="334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hakal, Alfa" userId="S::aldhakal@iu.edu::47175381-e0f0-42f2-a909-d585e2a70e98" providerId="AD" clId="Web-{40EA5B56-DB12-A426-43BC-C8CF6484C009}"/>
    <pc:docChg chg="modSld">
      <pc:chgData name="Dhakal, Alfa" userId="S::aldhakal@iu.edu::47175381-e0f0-42f2-a909-d585e2a70e98" providerId="AD" clId="Web-{40EA5B56-DB12-A426-43BC-C8CF6484C009}" dt="2024-01-23T17:33:46.951" v="82" actId="20577"/>
      <pc:docMkLst>
        <pc:docMk/>
      </pc:docMkLst>
      <pc:sldChg chg="modSp">
        <pc:chgData name="Dhakal, Alfa" userId="S::aldhakal@iu.edu::47175381-e0f0-42f2-a909-d585e2a70e98" providerId="AD" clId="Web-{40EA5B56-DB12-A426-43BC-C8CF6484C009}" dt="2024-01-23T17:33:46.951" v="82" actId="20577"/>
        <pc:sldMkLst>
          <pc:docMk/>
          <pc:sldMk cId="2398142653" sldId="259"/>
        </pc:sldMkLst>
        <pc:spChg chg="mod">
          <ac:chgData name="Dhakal, Alfa" userId="S::aldhakal@iu.edu::47175381-e0f0-42f2-a909-d585e2a70e98" providerId="AD" clId="Web-{40EA5B56-DB12-A426-43BC-C8CF6484C009}" dt="2024-01-23T17:33:46.951" v="82" actId="20577"/>
          <ac:spMkLst>
            <pc:docMk/>
            <pc:sldMk cId="2398142653" sldId="259"/>
            <ac:spMk id="2" creationId="{08497AB2-100A-8C97-D4A1-1D8382D5480C}"/>
          </ac:spMkLst>
        </pc:spChg>
      </pc:sldChg>
    </pc:docChg>
  </pc:docChgLst>
  <pc:docChgLst>
    <pc:chgData name="Hundley, Heather Ann" userId="9923bbf4-35ca-4515-b4c1-83653bfb90e1" providerId="ADAL" clId="{0B8975B7-4B55-E64E-BC11-7E38A7E56738}"/>
    <pc:docChg chg="modSld">
      <pc:chgData name="Hundley, Heather Ann" userId="9923bbf4-35ca-4515-b4c1-83653bfb90e1" providerId="ADAL" clId="{0B8975B7-4B55-E64E-BC11-7E38A7E56738}" dt="2024-01-24T20:17:28.410" v="55" actId="20577"/>
      <pc:docMkLst>
        <pc:docMk/>
      </pc:docMkLst>
      <pc:sldChg chg="modSp mod">
        <pc:chgData name="Hundley, Heather Ann" userId="9923bbf4-35ca-4515-b4c1-83653bfb90e1" providerId="ADAL" clId="{0B8975B7-4B55-E64E-BC11-7E38A7E56738}" dt="2024-01-24T20:17:23.082" v="54" actId="20577"/>
        <pc:sldMkLst>
          <pc:docMk/>
          <pc:sldMk cId="2398142653" sldId="259"/>
        </pc:sldMkLst>
        <pc:spChg chg="mod">
          <ac:chgData name="Hundley, Heather Ann" userId="9923bbf4-35ca-4515-b4c1-83653bfb90e1" providerId="ADAL" clId="{0B8975B7-4B55-E64E-BC11-7E38A7E56738}" dt="2024-01-24T20:13:58.886" v="51" actId="20577"/>
          <ac:spMkLst>
            <pc:docMk/>
            <pc:sldMk cId="2398142653" sldId="259"/>
            <ac:spMk id="2" creationId="{08497AB2-100A-8C97-D4A1-1D8382D5480C}"/>
          </ac:spMkLst>
        </pc:spChg>
        <pc:spChg chg="mod">
          <ac:chgData name="Hundley, Heather Ann" userId="9923bbf4-35ca-4515-b4c1-83653bfb90e1" providerId="ADAL" clId="{0B8975B7-4B55-E64E-BC11-7E38A7E56738}" dt="2024-01-24T20:17:18.224" v="53" actId="20577"/>
          <ac:spMkLst>
            <pc:docMk/>
            <pc:sldMk cId="2398142653" sldId="259"/>
            <ac:spMk id="26" creationId="{4B258552-E4E7-E0F9-218E-CAB66E9E48A6}"/>
          </ac:spMkLst>
        </pc:spChg>
        <pc:spChg chg="mod">
          <ac:chgData name="Hundley, Heather Ann" userId="9923bbf4-35ca-4515-b4c1-83653bfb90e1" providerId="ADAL" clId="{0B8975B7-4B55-E64E-BC11-7E38A7E56738}" dt="2024-01-24T20:17:23.082" v="54" actId="20577"/>
          <ac:spMkLst>
            <pc:docMk/>
            <pc:sldMk cId="2398142653" sldId="259"/>
            <ac:spMk id="30" creationId="{98DB1695-CB74-28ED-DC68-5C7EE98B0F94}"/>
          </ac:spMkLst>
        </pc:spChg>
      </pc:sldChg>
      <pc:sldChg chg="modSp mod">
        <pc:chgData name="Hundley, Heather Ann" userId="9923bbf4-35ca-4515-b4c1-83653bfb90e1" providerId="ADAL" clId="{0B8975B7-4B55-E64E-BC11-7E38A7E56738}" dt="2024-01-24T20:17:28.410" v="55" actId="20577"/>
        <pc:sldMkLst>
          <pc:docMk/>
          <pc:sldMk cId="2638478859" sldId="260"/>
        </pc:sldMkLst>
        <pc:spChg chg="mod">
          <ac:chgData name="Hundley, Heather Ann" userId="9923bbf4-35ca-4515-b4c1-83653bfb90e1" providerId="ADAL" clId="{0B8975B7-4B55-E64E-BC11-7E38A7E56738}" dt="2024-01-24T20:17:28.410" v="55" actId="20577"/>
          <ac:spMkLst>
            <pc:docMk/>
            <pc:sldMk cId="2638478859" sldId="260"/>
            <ac:spMk id="9" creationId="{7CD1207E-68EA-5EAC-F601-B97FF20DBEC0}"/>
          </ac:spMkLst>
        </pc:spChg>
      </pc:sldChg>
    </pc:docChg>
  </pc:docChgLst>
  <pc:docChgLst>
    <pc:chgData name="Dhakal, Alfa" userId="S::aldhakal@iu.edu::47175381-e0f0-42f2-a909-d585e2a70e98" providerId="AD" clId="Web-{BCF0CDA2-F36C-63AD-96C7-A4D01E0829BA}"/>
    <pc:docChg chg="modSld">
      <pc:chgData name="Dhakal, Alfa" userId="S::aldhakal@iu.edu::47175381-e0f0-42f2-a909-d585e2a70e98" providerId="AD" clId="Web-{BCF0CDA2-F36C-63AD-96C7-A4D01E0829BA}" dt="2024-01-24T15:25:08.753" v="18" actId="20577"/>
      <pc:docMkLst>
        <pc:docMk/>
      </pc:docMkLst>
      <pc:sldChg chg="modSp">
        <pc:chgData name="Dhakal, Alfa" userId="S::aldhakal@iu.edu::47175381-e0f0-42f2-a909-d585e2a70e98" providerId="AD" clId="Web-{BCF0CDA2-F36C-63AD-96C7-A4D01E0829BA}" dt="2024-01-24T15:25:08.753" v="18" actId="20577"/>
        <pc:sldMkLst>
          <pc:docMk/>
          <pc:sldMk cId="2398142653" sldId="259"/>
        </pc:sldMkLst>
        <pc:spChg chg="mod">
          <ac:chgData name="Dhakal, Alfa" userId="S::aldhakal@iu.edu::47175381-e0f0-42f2-a909-d585e2a70e98" providerId="AD" clId="Web-{BCF0CDA2-F36C-63AD-96C7-A4D01E0829BA}" dt="2024-01-24T15:25:08.753" v="18" actId="20577"/>
          <ac:spMkLst>
            <pc:docMk/>
            <pc:sldMk cId="2398142653" sldId="259"/>
            <ac:spMk id="2" creationId="{08497AB2-100A-8C97-D4A1-1D8382D5480C}"/>
          </ac:spMkLst>
        </pc:spChg>
      </pc:sldChg>
    </pc:docChg>
  </pc:docChgLst>
  <pc:docChgLst>
    <pc:chgData name="Dhakal, Alfa" userId="S::aldhakal@iu.edu::47175381-e0f0-42f2-a909-d585e2a70e98" providerId="AD" clId="Web-{62A86719-0574-2A4C-B148-33F8077C15D8}"/>
    <pc:docChg chg="modSld">
      <pc:chgData name="Dhakal, Alfa" userId="S::aldhakal@iu.edu::47175381-e0f0-42f2-a909-d585e2a70e98" providerId="AD" clId="Web-{62A86719-0574-2A4C-B148-33F8077C15D8}" dt="2024-01-23T16:30:38.994" v="77" actId="20577"/>
      <pc:docMkLst>
        <pc:docMk/>
      </pc:docMkLst>
      <pc:sldChg chg="addSp modSp">
        <pc:chgData name="Dhakal, Alfa" userId="S::aldhakal@iu.edu::47175381-e0f0-42f2-a909-d585e2a70e98" providerId="AD" clId="Web-{62A86719-0574-2A4C-B148-33F8077C15D8}" dt="2024-01-23T16:30:38.994" v="77" actId="20577"/>
        <pc:sldMkLst>
          <pc:docMk/>
          <pc:sldMk cId="2398142653" sldId="259"/>
        </pc:sldMkLst>
        <pc:spChg chg="mod">
          <ac:chgData name="Dhakal, Alfa" userId="S::aldhakal@iu.edu::47175381-e0f0-42f2-a909-d585e2a70e98" providerId="AD" clId="Web-{62A86719-0574-2A4C-B148-33F8077C15D8}" dt="2024-01-23T16:30:38.994" v="77" actId="20577"/>
          <ac:spMkLst>
            <pc:docMk/>
            <pc:sldMk cId="2398142653" sldId="259"/>
            <ac:spMk id="2" creationId="{08497AB2-100A-8C97-D4A1-1D8382D5480C}"/>
          </ac:spMkLst>
        </pc:spChg>
        <pc:spChg chg="add mod">
          <ac:chgData name="Dhakal, Alfa" userId="S::aldhakal@iu.edu::47175381-e0f0-42f2-a909-d585e2a70e98" providerId="AD" clId="Web-{62A86719-0574-2A4C-B148-33F8077C15D8}" dt="2024-01-23T16:29:08.850" v="8"/>
          <ac:spMkLst>
            <pc:docMk/>
            <pc:sldMk cId="2398142653" sldId="259"/>
            <ac:spMk id="5" creationId="{CBD19C46-A7C5-8C76-7B23-08C99CE64254}"/>
          </ac:spMkLst>
        </pc:spChg>
        <pc:spChg chg="add mod">
          <ac:chgData name="Dhakal, Alfa" userId="S::aldhakal@iu.edu::47175381-e0f0-42f2-a909-d585e2a70e98" providerId="AD" clId="Web-{62A86719-0574-2A4C-B148-33F8077C15D8}" dt="2024-01-23T16:29:23.538" v="10" actId="1076"/>
          <ac:spMkLst>
            <pc:docMk/>
            <pc:sldMk cId="2398142653" sldId="259"/>
            <ac:spMk id="6" creationId="{25A2C2D1-DAC3-CBB7-33DD-202E7B744A79}"/>
          </ac:spMkLst>
        </pc:spChg>
      </pc:sldChg>
      <pc:sldChg chg="addSp modSp">
        <pc:chgData name="Dhakal, Alfa" userId="S::aldhakal@iu.edu::47175381-e0f0-42f2-a909-d585e2a70e98" providerId="AD" clId="Web-{62A86719-0574-2A4C-B148-33F8077C15D8}" dt="2024-01-23T16:29:42.570" v="12" actId="1076"/>
        <pc:sldMkLst>
          <pc:docMk/>
          <pc:sldMk cId="2638478859" sldId="260"/>
        </pc:sldMkLst>
        <pc:spChg chg="add mod">
          <ac:chgData name="Dhakal, Alfa" userId="S::aldhakal@iu.edu::47175381-e0f0-42f2-a909-d585e2a70e98" providerId="AD" clId="Web-{62A86719-0574-2A4C-B148-33F8077C15D8}" dt="2024-01-23T16:29:42.570" v="12" actId="1076"/>
          <ac:spMkLst>
            <pc:docMk/>
            <pc:sldMk cId="2638478859" sldId="260"/>
            <ac:spMk id="4" creationId="{CA02BCCE-8911-C858-7B1A-5141E8451F5C}"/>
          </ac:spMkLst>
        </pc:spChg>
      </pc:sldChg>
    </pc:docChg>
  </pc:docChgLst>
  <pc:docChgLst>
    <pc:chgData name="Salim, Chinnu" userId="S::chisalim@iu.edu::97f0121d-12bb-4de1-b0c3-9497d3c11a4c" providerId="AD" clId="Web-{8A336E61-CEB3-3249-FD39-D222D0E0797F}"/>
    <pc:docChg chg="modSld">
      <pc:chgData name="Salim, Chinnu" userId="S::chisalim@iu.edu::97f0121d-12bb-4de1-b0c3-9497d3c11a4c" providerId="AD" clId="Web-{8A336E61-CEB3-3249-FD39-D222D0E0797F}" dt="2024-01-24T20:56:47.625" v="21" actId="20577"/>
      <pc:docMkLst>
        <pc:docMk/>
      </pc:docMkLst>
      <pc:sldChg chg="modSp">
        <pc:chgData name="Salim, Chinnu" userId="S::chisalim@iu.edu::97f0121d-12bb-4de1-b0c3-9497d3c11a4c" providerId="AD" clId="Web-{8A336E61-CEB3-3249-FD39-D222D0E0797F}" dt="2024-01-24T20:56:47.625" v="21" actId="20577"/>
        <pc:sldMkLst>
          <pc:docMk/>
          <pc:sldMk cId="2398142653" sldId="259"/>
        </pc:sldMkLst>
        <pc:spChg chg="mod">
          <ac:chgData name="Salim, Chinnu" userId="S::chisalim@iu.edu::97f0121d-12bb-4de1-b0c3-9497d3c11a4c" providerId="AD" clId="Web-{8A336E61-CEB3-3249-FD39-D222D0E0797F}" dt="2024-01-24T20:56:47.625" v="21" actId="20577"/>
          <ac:spMkLst>
            <pc:docMk/>
            <pc:sldMk cId="2398142653" sldId="259"/>
            <ac:spMk id="2" creationId="{08497AB2-100A-8C97-D4A1-1D8382D5480C}"/>
          </ac:spMkLst>
        </pc:spChg>
      </pc:sldChg>
    </pc:docChg>
  </pc:docChgLst>
  <pc:docChgLst>
    <pc:chgData name="Dhakal, Alfa" userId="S::aldhakal@iu.edu::47175381-e0f0-42f2-a909-d585e2a70e98" providerId="AD" clId="Web-{073B270A-7899-4DAB-50FF-E69C57E52E93}"/>
    <pc:docChg chg="modSld">
      <pc:chgData name="Dhakal, Alfa" userId="S::aldhakal@iu.edu::47175381-e0f0-42f2-a909-d585e2a70e98" providerId="AD" clId="Web-{073B270A-7899-4DAB-50FF-E69C57E52E93}" dt="2024-01-23T16:50:24.661" v="102" actId="1076"/>
      <pc:docMkLst>
        <pc:docMk/>
      </pc:docMkLst>
      <pc:sldChg chg="modSp">
        <pc:chgData name="Dhakal, Alfa" userId="S::aldhakal@iu.edu::47175381-e0f0-42f2-a909-d585e2a70e98" providerId="AD" clId="Web-{073B270A-7899-4DAB-50FF-E69C57E52E93}" dt="2024-01-23T16:50:24.661" v="102" actId="1076"/>
        <pc:sldMkLst>
          <pc:docMk/>
          <pc:sldMk cId="2398142653" sldId="259"/>
        </pc:sldMkLst>
        <pc:spChg chg="mod ord">
          <ac:chgData name="Dhakal, Alfa" userId="S::aldhakal@iu.edu::47175381-e0f0-42f2-a909-d585e2a70e98" providerId="AD" clId="Web-{073B270A-7899-4DAB-50FF-E69C57E52E93}" dt="2024-01-23T16:50:12.770" v="78"/>
          <ac:spMkLst>
            <pc:docMk/>
            <pc:sldMk cId="2398142653" sldId="259"/>
            <ac:spMk id="2" creationId="{08497AB2-100A-8C97-D4A1-1D8382D5480C}"/>
          </ac:spMkLst>
        </pc:spChg>
        <pc:spChg chg="mod ord">
          <ac:chgData name="Dhakal, Alfa" userId="S::aldhakal@iu.edu::47175381-e0f0-42f2-a909-d585e2a70e98" providerId="AD" clId="Web-{073B270A-7899-4DAB-50FF-E69C57E52E93}" dt="2024-01-23T16:50:24.255" v="100" actId="1076"/>
          <ac:spMkLst>
            <pc:docMk/>
            <pc:sldMk cId="2398142653" sldId="259"/>
            <ac:spMk id="3" creationId="{07B4260B-17F8-0043-69EC-7CFAFB13CE1A}"/>
          </ac:spMkLst>
        </pc:spChg>
        <pc:spChg chg="mod">
          <ac:chgData name="Dhakal, Alfa" userId="S::aldhakal@iu.edu::47175381-e0f0-42f2-a909-d585e2a70e98" providerId="AD" clId="Web-{073B270A-7899-4DAB-50FF-E69C57E52E93}" dt="2024-01-23T16:50:24.661" v="102" actId="1076"/>
          <ac:spMkLst>
            <pc:docMk/>
            <pc:sldMk cId="2398142653" sldId="259"/>
            <ac:spMk id="5" creationId="{CBD19C46-A7C5-8C76-7B23-08C99CE64254}"/>
          </ac:spMkLst>
        </pc:spChg>
        <pc:spChg chg="mod ord">
          <ac:chgData name="Dhakal, Alfa" userId="S::aldhakal@iu.edu::47175381-e0f0-42f2-a909-d585e2a70e98" providerId="AD" clId="Web-{073B270A-7899-4DAB-50FF-E69C57E52E93}" dt="2024-01-23T16:50:23.849" v="88" actId="1076"/>
          <ac:spMkLst>
            <pc:docMk/>
            <pc:sldMk cId="2398142653" sldId="259"/>
            <ac:spMk id="16" creationId="{DFFDA3E1-CC0A-D8EE-04F1-D55252392549}"/>
          </ac:spMkLst>
        </pc:spChg>
        <pc:spChg chg="ord">
          <ac:chgData name="Dhakal, Alfa" userId="S::aldhakal@iu.edu::47175381-e0f0-42f2-a909-d585e2a70e98" providerId="AD" clId="Web-{073B270A-7899-4DAB-50FF-E69C57E52E93}" dt="2024-01-23T16:50:10.661" v="69"/>
          <ac:spMkLst>
            <pc:docMk/>
            <pc:sldMk cId="2398142653" sldId="259"/>
            <ac:spMk id="17" creationId="{9D4448E8-C797-2581-ABFC-38FAE1311E09}"/>
          </ac:spMkLst>
        </pc:spChg>
        <pc:spChg chg="ord">
          <ac:chgData name="Dhakal, Alfa" userId="S::aldhakal@iu.edu::47175381-e0f0-42f2-a909-d585e2a70e98" providerId="AD" clId="Web-{073B270A-7899-4DAB-50FF-E69C57E52E93}" dt="2024-01-23T16:50:08.254" v="60"/>
          <ac:spMkLst>
            <pc:docMk/>
            <pc:sldMk cId="2398142653" sldId="259"/>
            <ac:spMk id="18" creationId="{E9D6EB2C-8558-12C0-5628-863A2E700FD6}"/>
          </ac:spMkLst>
        </pc:spChg>
        <pc:spChg chg="mod">
          <ac:chgData name="Dhakal, Alfa" userId="S::aldhakal@iu.edu::47175381-e0f0-42f2-a909-d585e2a70e98" providerId="AD" clId="Web-{073B270A-7899-4DAB-50FF-E69C57E52E93}" dt="2024-01-23T16:50:23.911" v="89" actId="1076"/>
          <ac:spMkLst>
            <pc:docMk/>
            <pc:sldMk cId="2398142653" sldId="259"/>
            <ac:spMk id="26" creationId="{4B258552-E4E7-E0F9-218E-CAB66E9E48A6}"/>
          </ac:spMkLst>
        </pc:spChg>
        <pc:spChg chg="mod ord">
          <ac:chgData name="Dhakal, Alfa" userId="S::aldhakal@iu.edu::47175381-e0f0-42f2-a909-d585e2a70e98" providerId="AD" clId="Web-{073B270A-7899-4DAB-50FF-E69C57E52E93}" dt="2024-01-23T16:50:24.521" v="101" actId="1076"/>
          <ac:spMkLst>
            <pc:docMk/>
            <pc:sldMk cId="2398142653" sldId="259"/>
            <ac:spMk id="28" creationId="{88C60C91-89C4-88A4-C654-00AE1985E2E4}"/>
          </ac:spMkLst>
        </pc:spChg>
        <pc:spChg chg="ord">
          <ac:chgData name="Dhakal, Alfa" userId="S::aldhakal@iu.edu::47175381-e0f0-42f2-a909-d585e2a70e98" providerId="AD" clId="Web-{073B270A-7899-4DAB-50FF-E69C57E52E93}" dt="2024-01-23T16:50:02.957" v="41"/>
          <ac:spMkLst>
            <pc:docMk/>
            <pc:sldMk cId="2398142653" sldId="259"/>
            <ac:spMk id="30" creationId="{98DB1695-CB74-28ED-DC68-5C7EE98B0F94}"/>
          </ac:spMkLst>
        </pc:spChg>
        <pc:spChg chg="mod">
          <ac:chgData name="Dhakal, Alfa" userId="S::aldhakal@iu.edu::47175381-e0f0-42f2-a909-d585e2a70e98" providerId="AD" clId="Web-{073B270A-7899-4DAB-50FF-E69C57E52E93}" dt="2024-01-23T16:50:24.036" v="92" actId="1076"/>
          <ac:spMkLst>
            <pc:docMk/>
            <pc:sldMk cId="2398142653" sldId="259"/>
            <ac:spMk id="35" creationId="{CC0098FA-2F1B-0698-E55F-5299F3A59073}"/>
          </ac:spMkLst>
        </pc:spChg>
        <pc:spChg chg="mod">
          <ac:chgData name="Dhakal, Alfa" userId="S::aldhakal@iu.edu::47175381-e0f0-42f2-a909-d585e2a70e98" providerId="AD" clId="Web-{073B270A-7899-4DAB-50FF-E69C57E52E93}" dt="2024-01-23T16:50:24.068" v="93" actId="1076"/>
          <ac:spMkLst>
            <pc:docMk/>
            <pc:sldMk cId="2398142653" sldId="259"/>
            <ac:spMk id="36" creationId="{AA477702-B834-DC7F-7B34-4CC449F50D92}"/>
          </ac:spMkLst>
        </pc:spChg>
        <pc:spChg chg="mod">
          <ac:chgData name="Dhakal, Alfa" userId="S::aldhakal@iu.edu::47175381-e0f0-42f2-a909-d585e2a70e98" providerId="AD" clId="Web-{073B270A-7899-4DAB-50FF-E69C57E52E93}" dt="2024-01-23T16:50:24.085" v="94" actId="1076"/>
          <ac:spMkLst>
            <pc:docMk/>
            <pc:sldMk cId="2398142653" sldId="259"/>
            <ac:spMk id="37" creationId="{98D814D5-7DC1-C0C3-14FD-4FD02BEB4A43}"/>
          </ac:spMkLst>
        </pc:spChg>
        <pc:spChg chg="mod">
          <ac:chgData name="Dhakal, Alfa" userId="S::aldhakal@iu.edu::47175381-e0f0-42f2-a909-d585e2a70e98" providerId="AD" clId="Web-{073B270A-7899-4DAB-50FF-E69C57E52E93}" dt="2024-01-23T16:50:24.114" v="95" actId="1076"/>
          <ac:spMkLst>
            <pc:docMk/>
            <pc:sldMk cId="2398142653" sldId="259"/>
            <ac:spMk id="38" creationId="{2FB9963A-3093-52D9-C122-F05A9D94A96D}"/>
          </ac:spMkLst>
        </pc:spChg>
        <pc:spChg chg="mod">
          <ac:chgData name="Dhakal, Alfa" userId="S::aldhakal@iu.edu::47175381-e0f0-42f2-a909-d585e2a70e98" providerId="AD" clId="Web-{073B270A-7899-4DAB-50FF-E69C57E52E93}" dt="2024-01-23T16:50:24.146" v="96" actId="1076"/>
          <ac:spMkLst>
            <pc:docMk/>
            <pc:sldMk cId="2398142653" sldId="259"/>
            <ac:spMk id="39" creationId="{4E2E7A56-DF44-DCAA-AC83-8E157431ACB9}"/>
          </ac:spMkLst>
        </pc:spChg>
        <pc:spChg chg="mod">
          <ac:chgData name="Dhakal, Alfa" userId="S::aldhakal@iu.edu::47175381-e0f0-42f2-a909-d585e2a70e98" providerId="AD" clId="Web-{073B270A-7899-4DAB-50FF-E69C57E52E93}" dt="2024-01-23T16:50:24.177" v="97" actId="1076"/>
          <ac:spMkLst>
            <pc:docMk/>
            <pc:sldMk cId="2398142653" sldId="259"/>
            <ac:spMk id="40" creationId="{870CC7AA-4DF4-BD8A-A0EF-B48333064E39}"/>
          </ac:spMkLst>
        </pc:spChg>
        <pc:spChg chg="mod">
          <ac:chgData name="Dhakal, Alfa" userId="S::aldhakal@iu.edu::47175381-e0f0-42f2-a909-d585e2a70e98" providerId="AD" clId="Web-{073B270A-7899-4DAB-50FF-E69C57E52E93}" dt="2024-01-23T16:50:24.208" v="98" actId="1076"/>
          <ac:spMkLst>
            <pc:docMk/>
            <pc:sldMk cId="2398142653" sldId="259"/>
            <ac:spMk id="41" creationId="{AC052E2E-ED8B-E5B5-F216-EB39CDDB2983}"/>
          </ac:spMkLst>
        </pc:spChg>
        <pc:spChg chg="mod">
          <ac:chgData name="Dhakal, Alfa" userId="S::aldhakal@iu.edu::47175381-e0f0-42f2-a909-d585e2a70e98" providerId="AD" clId="Web-{073B270A-7899-4DAB-50FF-E69C57E52E93}" dt="2024-01-23T16:50:24.239" v="99" actId="1076"/>
          <ac:spMkLst>
            <pc:docMk/>
            <pc:sldMk cId="2398142653" sldId="259"/>
            <ac:spMk id="42" creationId="{878FD294-2F41-4BD5-2698-4BEE098949B4}"/>
          </ac:spMkLst>
        </pc:spChg>
        <pc:picChg chg="mod">
          <ac:chgData name="Dhakal, Alfa" userId="S::aldhakal@iu.edu::47175381-e0f0-42f2-a909-d585e2a70e98" providerId="AD" clId="Web-{073B270A-7899-4DAB-50FF-E69C57E52E93}" dt="2024-01-23T16:50:23.958" v="90" actId="1076"/>
          <ac:picMkLst>
            <pc:docMk/>
            <pc:sldMk cId="2398142653" sldId="259"/>
            <ac:picMk id="27" creationId="{D4934E7A-40E6-E538-3B11-AD610ECC7D6C}"/>
          </ac:picMkLst>
        </pc:picChg>
        <pc:picChg chg="mod ord">
          <ac:chgData name="Dhakal, Alfa" userId="S::aldhakal@iu.edu::47175381-e0f0-42f2-a909-d585e2a70e98" providerId="AD" clId="Web-{073B270A-7899-4DAB-50FF-E69C57E52E93}" dt="2024-01-23T16:50:24.005" v="91" actId="1076"/>
          <ac:picMkLst>
            <pc:docMk/>
            <pc:sldMk cId="2398142653" sldId="259"/>
            <ac:picMk id="29" creationId="{412B5CA8-1100-0C67-528B-D2B2B6A131B6}"/>
          </ac:picMkLst>
        </pc:picChg>
        <pc:picChg chg="ord">
          <ac:chgData name="Dhakal, Alfa" userId="S::aldhakal@iu.edu::47175381-e0f0-42f2-a909-d585e2a70e98" providerId="AD" clId="Web-{073B270A-7899-4DAB-50FF-E69C57E52E93}" dt="2024-01-23T16:49:58.910" v="29"/>
          <ac:picMkLst>
            <pc:docMk/>
            <pc:sldMk cId="2398142653" sldId="259"/>
            <ac:picMk id="31" creationId="{40FF6DC3-C336-FF14-4C19-D8B6DA3F4EC2}"/>
          </ac:picMkLst>
        </pc:picChg>
        <pc:picChg chg="ord">
          <ac:chgData name="Dhakal, Alfa" userId="S::aldhakal@iu.edu::47175381-e0f0-42f2-a909-d585e2a70e98" providerId="AD" clId="Web-{073B270A-7899-4DAB-50FF-E69C57E52E93}" dt="2024-01-23T16:49:54.457" v="17"/>
          <ac:picMkLst>
            <pc:docMk/>
            <pc:sldMk cId="2398142653" sldId="259"/>
            <ac:picMk id="33" creationId="{FE8E8AD3-79B4-28A0-D17A-F408F17C9EC1}"/>
          </ac:picMkLst>
        </pc:picChg>
      </pc:sldChg>
    </pc:docChg>
  </pc:docChgLst>
  <pc:docChgLst>
    <pc:chgData name="Dhakal, Alfa" userId="S::aldhakal@iu.edu::47175381-e0f0-42f2-a909-d585e2a70e98" providerId="AD" clId="Web-{9625A293-8E58-EC2E-1CF5-E2DAD4A02FC4}"/>
    <pc:docChg chg="modSld">
      <pc:chgData name="Dhakal, Alfa" userId="S::aldhakal@iu.edu::47175381-e0f0-42f2-a909-d585e2a70e98" providerId="AD" clId="Web-{9625A293-8E58-EC2E-1CF5-E2DAD4A02FC4}" dt="2024-01-22T20:40:10.617" v="337" actId="14100"/>
      <pc:docMkLst>
        <pc:docMk/>
      </pc:docMkLst>
      <pc:sldChg chg="addSp modSp">
        <pc:chgData name="Dhakal, Alfa" userId="S::aldhakal@iu.edu::47175381-e0f0-42f2-a909-d585e2a70e98" providerId="AD" clId="Web-{9625A293-8E58-EC2E-1CF5-E2DAD4A02FC4}" dt="2024-01-22T20:40:10.617" v="337" actId="14100"/>
        <pc:sldMkLst>
          <pc:docMk/>
          <pc:sldMk cId="2398142653" sldId="259"/>
        </pc:sldMkLst>
        <pc:spChg chg="mod">
          <ac:chgData name="Dhakal, Alfa" userId="S::aldhakal@iu.edu::47175381-e0f0-42f2-a909-d585e2a70e98" providerId="AD" clId="Web-{9625A293-8E58-EC2E-1CF5-E2DAD4A02FC4}" dt="2024-01-22T20:24:39.400" v="70"/>
          <ac:spMkLst>
            <pc:docMk/>
            <pc:sldMk cId="2398142653" sldId="259"/>
            <ac:spMk id="2" creationId="{08497AB2-100A-8C97-D4A1-1D8382D5480C}"/>
          </ac:spMkLst>
        </pc:spChg>
        <pc:spChg chg="add mod">
          <ac:chgData name="Dhakal, Alfa" userId="S::aldhakal@iu.edu::47175381-e0f0-42f2-a909-d585e2a70e98" providerId="AD" clId="Web-{9625A293-8E58-EC2E-1CF5-E2DAD4A02FC4}" dt="2024-01-22T20:30:06.707" v="125" actId="20577"/>
          <ac:spMkLst>
            <pc:docMk/>
            <pc:sldMk cId="2398142653" sldId="259"/>
            <ac:spMk id="3" creationId="{07B4260B-17F8-0043-69EC-7CFAFB13CE1A}"/>
          </ac:spMkLst>
        </pc:spChg>
        <pc:spChg chg="add mod">
          <ac:chgData name="Dhakal, Alfa" userId="S::aldhakal@iu.edu::47175381-e0f0-42f2-a909-d585e2a70e98" providerId="AD" clId="Web-{9625A293-8E58-EC2E-1CF5-E2DAD4A02FC4}" dt="2024-01-22T20:35:45.718" v="253" actId="1076"/>
          <ac:spMkLst>
            <pc:docMk/>
            <pc:sldMk cId="2398142653" sldId="259"/>
            <ac:spMk id="4" creationId="{881E7850-1F8F-1C9D-770A-5E75A6A5F618}"/>
          </ac:spMkLst>
        </pc:spChg>
        <pc:spChg chg="mod">
          <ac:chgData name="Dhakal, Alfa" userId="S::aldhakal@iu.edu::47175381-e0f0-42f2-a909-d585e2a70e98" providerId="AD" clId="Web-{9625A293-8E58-EC2E-1CF5-E2DAD4A02FC4}" dt="2024-01-22T20:29:16.112" v="116" actId="14100"/>
          <ac:spMkLst>
            <pc:docMk/>
            <pc:sldMk cId="2398142653" sldId="259"/>
            <ac:spMk id="16" creationId="{DFFDA3E1-CC0A-D8EE-04F1-D55252392549}"/>
          </ac:spMkLst>
        </pc:spChg>
        <pc:spChg chg="mod">
          <ac:chgData name="Dhakal, Alfa" userId="S::aldhakal@iu.edu::47175381-e0f0-42f2-a909-d585e2a70e98" providerId="AD" clId="Web-{9625A293-8E58-EC2E-1CF5-E2DAD4A02FC4}" dt="2024-01-22T20:35:52.750" v="254" actId="1076"/>
          <ac:spMkLst>
            <pc:docMk/>
            <pc:sldMk cId="2398142653" sldId="259"/>
            <ac:spMk id="17" creationId="{9D4448E8-C797-2581-ABFC-38FAE1311E09}"/>
          </ac:spMkLst>
        </pc:spChg>
        <pc:spChg chg="mod">
          <ac:chgData name="Dhakal, Alfa" userId="S::aldhakal@iu.edu::47175381-e0f0-42f2-a909-d585e2a70e98" providerId="AD" clId="Web-{9625A293-8E58-EC2E-1CF5-E2DAD4A02FC4}" dt="2024-01-22T20:35:57.625" v="255" actId="1076"/>
          <ac:spMkLst>
            <pc:docMk/>
            <pc:sldMk cId="2398142653" sldId="259"/>
            <ac:spMk id="18" creationId="{E9D6EB2C-8558-12C0-5628-863A2E700FD6}"/>
          </ac:spMkLst>
        </pc:spChg>
        <pc:spChg chg="mod">
          <ac:chgData name="Dhakal, Alfa" userId="S::aldhakal@iu.edu::47175381-e0f0-42f2-a909-d585e2a70e98" providerId="AD" clId="Web-{9625A293-8E58-EC2E-1CF5-E2DAD4A02FC4}" dt="2024-01-22T20:33:11.635" v="190" actId="20577"/>
          <ac:spMkLst>
            <pc:docMk/>
            <pc:sldMk cId="2398142653" sldId="259"/>
            <ac:spMk id="26" creationId="{4B258552-E4E7-E0F9-218E-CAB66E9E48A6}"/>
          </ac:spMkLst>
        </pc:spChg>
        <pc:spChg chg="mod">
          <ac:chgData name="Dhakal, Alfa" userId="S::aldhakal@iu.edu::47175381-e0f0-42f2-a909-d585e2a70e98" providerId="AD" clId="Web-{9625A293-8E58-EC2E-1CF5-E2DAD4A02FC4}" dt="2024-01-22T20:29:19.956" v="117" actId="14100"/>
          <ac:spMkLst>
            <pc:docMk/>
            <pc:sldMk cId="2398142653" sldId="259"/>
            <ac:spMk id="28" creationId="{88C60C91-89C4-88A4-C654-00AE1985E2E4}"/>
          </ac:spMkLst>
        </pc:spChg>
        <pc:spChg chg="mod">
          <ac:chgData name="Dhakal, Alfa" userId="S::aldhakal@iu.edu::47175381-e0f0-42f2-a909-d585e2a70e98" providerId="AD" clId="Web-{9625A293-8E58-EC2E-1CF5-E2DAD4A02FC4}" dt="2024-01-22T20:36:11.078" v="258" actId="20577"/>
          <ac:spMkLst>
            <pc:docMk/>
            <pc:sldMk cId="2398142653" sldId="259"/>
            <ac:spMk id="30" creationId="{98DB1695-CB74-28ED-DC68-5C7EE98B0F94}"/>
          </ac:spMkLst>
        </pc:spChg>
        <pc:spChg chg="mod">
          <ac:chgData name="Dhakal, Alfa" userId="S::aldhakal@iu.edu::47175381-e0f0-42f2-a909-d585e2a70e98" providerId="AD" clId="Web-{9625A293-8E58-EC2E-1CF5-E2DAD4A02FC4}" dt="2024-01-22T20:30:33.614" v="126" actId="1076"/>
          <ac:spMkLst>
            <pc:docMk/>
            <pc:sldMk cId="2398142653" sldId="259"/>
            <ac:spMk id="35" creationId="{CC0098FA-2F1B-0698-E55F-5299F3A59073}"/>
          </ac:spMkLst>
        </pc:spChg>
        <pc:spChg chg="mod">
          <ac:chgData name="Dhakal, Alfa" userId="S::aldhakal@iu.edu::47175381-e0f0-42f2-a909-d585e2a70e98" providerId="AD" clId="Web-{9625A293-8E58-EC2E-1CF5-E2DAD4A02FC4}" dt="2024-01-22T20:30:33.646" v="127" actId="1076"/>
          <ac:spMkLst>
            <pc:docMk/>
            <pc:sldMk cId="2398142653" sldId="259"/>
            <ac:spMk id="36" creationId="{AA477702-B834-DC7F-7B34-4CC449F50D92}"/>
          </ac:spMkLst>
        </pc:spChg>
        <pc:spChg chg="mod">
          <ac:chgData name="Dhakal, Alfa" userId="S::aldhakal@iu.edu::47175381-e0f0-42f2-a909-d585e2a70e98" providerId="AD" clId="Web-{9625A293-8E58-EC2E-1CF5-E2DAD4A02FC4}" dt="2024-01-22T20:30:33.661" v="128" actId="1076"/>
          <ac:spMkLst>
            <pc:docMk/>
            <pc:sldMk cId="2398142653" sldId="259"/>
            <ac:spMk id="37" creationId="{98D814D5-7DC1-C0C3-14FD-4FD02BEB4A43}"/>
          </ac:spMkLst>
        </pc:spChg>
        <pc:spChg chg="mod">
          <ac:chgData name="Dhakal, Alfa" userId="S::aldhakal@iu.edu::47175381-e0f0-42f2-a909-d585e2a70e98" providerId="AD" clId="Web-{9625A293-8E58-EC2E-1CF5-E2DAD4A02FC4}" dt="2024-01-22T20:30:45.724" v="135" actId="1076"/>
          <ac:spMkLst>
            <pc:docMk/>
            <pc:sldMk cId="2398142653" sldId="259"/>
            <ac:spMk id="38" creationId="{2FB9963A-3093-52D9-C122-F05A9D94A96D}"/>
          </ac:spMkLst>
        </pc:spChg>
        <pc:spChg chg="mod">
          <ac:chgData name="Dhakal, Alfa" userId="S::aldhakal@iu.edu::47175381-e0f0-42f2-a909-d585e2a70e98" providerId="AD" clId="Web-{9625A293-8E58-EC2E-1CF5-E2DAD4A02FC4}" dt="2024-01-22T20:30:33.708" v="130" actId="1076"/>
          <ac:spMkLst>
            <pc:docMk/>
            <pc:sldMk cId="2398142653" sldId="259"/>
            <ac:spMk id="39" creationId="{4E2E7A56-DF44-DCAA-AC83-8E157431ACB9}"/>
          </ac:spMkLst>
        </pc:spChg>
        <pc:spChg chg="mod">
          <ac:chgData name="Dhakal, Alfa" userId="S::aldhakal@iu.edu::47175381-e0f0-42f2-a909-d585e2a70e98" providerId="AD" clId="Web-{9625A293-8E58-EC2E-1CF5-E2DAD4A02FC4}" dt="2024-01-22T20:30:33.724" v="131" actId="1076"/>
          <ac:spMkLst>
            <pc:docMk/>
            <pc:sldMk cId="2398142653" sldId="259"/>
            <ac:spMk id="40" creationId="{870CC7AA-4DF4-BD8A-A0EF-B48333064E39}"/>
          </ac:spMkLst>
        </pc:spChg>
        <pc:spChg chg="mod">
          <ac:chgData name="Dhakal, Alfa" userId="S::aldhakal@iu.edu::47175381-e0f0-42f2-a909-d585e2a70e98" providerId="AD" clId="Web-{9625A293-8E58-EC2E-1CF5-E2DAD4A02FC4}" dt="2024-01-22T20:30:33.755" v="132" actId="1076"/>
          <ac:spMkLst>
            <pc:docMk/>
            <pc:sldMk cId="2398142653" sldId="259"/>
            <ac:spMk id="41" creationId="{AC052E2E-ED8B-E5B5-F216-EB39CDDB2983}"/>
          </ac:spMkLst>
        </pc:spChg>
        <pc:spChg chg="mod">
          <ac:chgData name="Dhakal, Alfa" userId="S::aldhakal@iu.edu::47175381-e0f0-42f2-a909-d585e2a70e98" providerId="AD" clId="Web-{9625A293-8E58-EC2E-1CF5-E2DAD4A02FC4}" dt="2024-01-22T20:30:49.130" v="136" actId="1076"/>
          <ac:spMkLst>
            <pc:docMk/>
            <pc:sldMk cId="2398142653" sldId="259"/>
            <ac:spMk id="42" creationId="{878FD294-2F41-4BD5-2698-4BEE098949B4}"/>
          </ac:spMkLst>
        </pc:spChg>
        <pc:spChg chg="mod">
          <ac:chgData name="Dhakal, Alfa" userId="S::aldhakal@iu.edu::47175381-e0f0-42f2-a909-d585e2a70e98" providerId="AD" clId="Web-{9625A293-8E58-EC2E-1CF5-E2DAD4A02FC4}" dt="2024-01-22T20:35:45.406" v="245" actId="1076"/>
          <ac:spMkLst>
            <pc:docMk/>
            <pc:sldMk cId="2398142653" sldId="259"/>
            <ac:spMk id="43" creationId="{99ED0230-8BD9-AA56-7CFD-DCC78AB3DB3A}"/>
          </ac:spMkLst>
        </pc:spChg>
        <pc:spChg chg="mod">
          <ac:chgData name="Dhakal, Alfa" userId="S::aldhakal@iu.edu::47175381-e0f0-42f2-a909-d585e2a70e98" providerId="AD" clId="Web-{9625A293-8E58-EC2E-1CF5-E2DAD4A02FC4}" dt="2024-01-22T20:35:45.437" v="246" actId="1076"/>
          <ac:spMkLst>
            <pc:docMk/>
            <pc:sldMk cId="2398142653" sldId="259"/>
            <ac:spMk id="44" creationId="{063B6C53-55F5-1D6F-09CE-A4619C20ACE5}"/>
          </ac:spMkLst>
        </pc:spChg>
        <pc:spChg chg="mod">
          <ac:chgData name="Dhakal, Alfa" userId="S::aldhakal@iu.edu::47175381-e0f0-42f2-a909-d585e2a70e98" providerId="AD" clId="Web-{9625A293-8E58-EC2E-1CF5-E2DAD4A02FC4}" dt="2024-01-22T20:35:45.484" v="247" actId="1076"/>
          <ac:spMkLst>
            <pc:docMk/>
            <pc:sldMk cId="2398142653" sldId="259"/>
            <ac:spMk id="45" creationId="{6427F8D4-7DF9-E801-A25F-915EA8438710}"/>
          </ac:spMkLst>
        </pc:spChg>
        <pc:spChg chg="mod">
          <ac:chgData name="Dhakal, Alfa" userId="S::aldhakal@iu.edu::47175381-e0f0-42f2-a909-d585e2a70e98" providerId="AD" clId="Web-{9625A293-8E58-EC2E-1CF5-E2DAD4A02FC4}" dt="2024-01-22T20:35:45.531" v="248" actId="1076"/>
          <ac:spMkLst>
            <pc:docMk/>
            <pc:sldMk cId="2398142653" sldId="259"/>
            <ac:spMk id="46" creationId="{A6BA71D8-45C0-973E-AD3A-A8F9E8A5D6DB}"/>
          </ac:spMkLst>
        </pc:spChg>
        <pc:spChg chg="mod">
          <ac:chgData name="Dhakal, Alfa" userId="S::aldhakal@iu.edu::47175381-e0f0-42f2-a909-d585e2a70e98" providerId="AD" clId="Web-{9625A293-8E58-EC2E-1CF5-E2DAD4A02FC4}" dt="2024-01-22T20:35:45.562" v="249" actId="1076"/>
          <ac:spMkLst>
            <pc:docMk/>
            <pc:sldMk cId="2398142653" sldId="259"/>
            <ac:spMk id="47" creationId="{371C5374-EA00-2A1C-D494-C476173E2D45}"/>
          </ac:spMkLst>
        </pc:spChg>
        <pc:spChg chg="mod">
          <ac:chgData name="Dhakal, Alfa" userId="S::aldhakal@iu.edu::47175381-e0f0-42f2-a909-d585e2a70e98" providerId="AD" clId="Web-{9625A293-8E58-EC2E-1CF5-E2DAD4A02FC4}" dt="2024-01-22T20:35:45.609" v="250" actId="1076"/>
          <ac:spMkLst>
            <pc:docMk/>
            <pc:sldMk cId="2398142653" sldId="259"/>
            <ac:spMk id="48" creationId="{6CD0D8D4-4FCD-FFE2-AF05-5BA7D5073D1E}"/>
          </ac:spMkLst>
        </pc:spChg>
        <pc:spChg chg="mod">
          <ac:chgData name="Dhakal, Alfa" userId="S::aldhakal@iu.edu::47175381-e0f0-42f2-a909-d585e2a70e98" providerId="AD" clId="Web-{9625A293-8E58-EC2E-1CF5-E2DAD4A02FC4}" dt="2024-01-22T20:35:45.640" v="251" actId="1076"/>
          <ac:spMkLst>
            <pc:docMk/>
            <pc:sldMk cId="2398142653" sldId="259"/>
            <ac:spMk id="49" creationId="{530EA3BF-EB96-382D-D88E-29FF2CB58322}"/>
          </ac:spMkLst>
        </pc:spChg>
        <pc:spChg chg="mod">
          <ac:chgData name="Dhakal, Alfa" userId="S::aldhakal@iu.edu::47175381-e0f0-42f2-a909-d585e2a70e98" providerId="AD" clId="Web-{9625A293-8E58-EC2E-1CF5-E2DAD4A02FC4}" dt="2024-01-22T20:35:45.687" v="252" actId="1076"/>
          <ac:spMkLst>
            <pc:docMk/>
            <pc:sldMk cId="2398142653" sldId="259"/>
            <ac:spMk id="50" creationId="{FE033502-093F-C72B-639C-6A47155326AF}"/>
          </ac:spMkLst>
        </pc:spChg>
        <pc:picChg chg="mod">
          <ac:chgData name="Dhakal, Alfa" userId="S::aldhakal@iu.edu::47175381-e0f0-42f2-a909-d585e2a70e98" providerId="AD" clId="Web-{9625A293-8E58-EC2E-1CF5-E2DAD4A02FC4}" dt="2024-01-22T20:29:49.738" v="122" actId="14100"/>
          <ac:picMkLst>
            <pc:docMk/>
            <pc:sldMk cId="2398142653" sldId="259"/>
            <ac:picMk id="27" creationId="{D4934E7A-40E6-E538-3B11-AD610ECC7D6C}"/>
          </ac:picMkLst>
        </pc:picChg>
        <pc:picChg chg="mod">
          <ac:chgData name="Dhakal, Alfa" userId="S::aldhakal@iu.edu::47175381-e0f0-42f2-a909-d585e2a70e98" providerId="AD" clId="Web-{9625A293-8E58-EC2E-1CF5-E2DAD4A02FC4}" dt="2024-01-22T20:30:41.208" v="134" actId="14100"/>
          <ac:picMkLst>
            <pc:docMk/>
            <pc:sldMk cId="2398142653" sldId="259"/>
            <ac:picMk id="29" creationId="{412B5CA8-1100-0C67-528B-D2B2B6A131B6}"/>
          </ac:picMkLst>
        </pc:picChg>
        <pc:picChg chg="mod">
          <ac:chgData name="Dhakal, Alfa" userId="S::aldhakal@iu.edu::47175381-e0f0-42f2-a909-d585e2a70e98" providerId="AD" clId="Web-{9625A293-8E58-EC2E-1CF5-E2DAD4A02FC4}" dt="2024-01-22T20:40:10.617" v="337" actId="14100"/>
          <ac:picMkLst>
            <pc:docMk/>
            <pc:sldMk cId="2398142653" sldId="259"/>
            <ac:picMk id="31" creationId="{40FF6DC3-C336-FF14-4C19-D8B6DA3F4EC2}"/>
          </ac:picMkLst>
        </pc:picChg>
        <pc:picChg chg="mod">
          <ac:chgData name="Dhakal, Alfa" userId="S::aldhakal@iu.edu::47175381-e0f0-42f2-a909-d585e2a70e98" providerId="AD" clId="Web-{9625A293-8E58-EC2E-1CF5-E2DAD4A02FC4}" dt="2024-01-22T20:35:45.390" v="244" actId="1076"/>
          <ac:picMkLst>
            <pc:docMk/>
            <pc:sldMk cId="2398142653" sldId="259"/>
            <ac:picMk id="33" creationId="{FE8E8AD3-79B4-28A0-D17A-F408F17C9EC1}"/>
          </ac:picMkLst>
        </pc:picChg>
      </pc:sldChg>
      <pc:sldChg chg="addSp modSp">
        <pc:chgData name="Dhakal, Alfa" userId="S::aldhakal@iu.edu::47175381-e0f0-42f2-a909-d585e2a70e98" providerId="AD" clId="Web-{9625A293-8E58-EC2E-1CF5-E2DAD4A02FC4}" dt="2024-01-22T20:39:37.757" v="336" actId="20577"/>
        <pc:sldMkLst>
          <pc:docMk/>
          <pc:sldMk cId="2638478859" sldId="260"/>
        </pc:sldMkLst>
        <pc:spChg chg="add mod">
          <ac:chgData name="Dhakal, Alfa" userId="S::aldhakal@iu.edu::47175381-e0f0-42f2-a909-d585e2a70e98" providerId="AD" clId="Web-{9625A293-8E58-EC2E-1CF5-E2DAD4A02FC4}" dt="2024-01-22T20:37:11.221" v="281" actId="1076"/>
          <ac:spMkLst>
            <pc:docMk/>
            <pc:sldMk cId="2638478859" sldId="260"/>
            <ac:spMk id="2" creationId="{D21863C5-371E-4FE0-C1E5-A89C0A365DB3}"/>
          </ac:spMkLst>
        </pc:spChg>
        <pc:spChg chg="mod">
          <ac:chgData name="Dhakal, Alfa" userId="S::aldhakal@iu.edu::47175381-e0f0-42f2-a909-d585e2a70e98" providerId="AD" clId="Web-{9625A293-8E58-EC2E-1CF5-E2DAD4A02FC4}" dt="2024-01-22T20:39:37.757" v="336" actId="20577"/>
          <ac:spMkLst>
            <pc:docMk/>
            <pc:sldMk cId="2638478859" sldId="260"/>
            <ac:spMk id="9" creationId="{7CD1207E-68EA-5EAC-F601-B97FF20DBEC0}"/>
          </ac:spMkLst>
        </pc:spChg>
        <pc:spChg chg="mod">
          <ac:chgData name="Dhakal, Alfa" userId="S::aldhakal@iu.edu::47175381-e0f0-42f2-a909-d585e2a70e98" providerId="AD" clId="Web-{9625A293-8E58-EC2E-1CF5-E2DAD4A02FC4}" dt="2024-01-22T20:37:22.174" v="283" actId="1076"/>
          <ac:spMkLst>
            <pc:docMk/>
            <pc:sldMk cId="2638478859" sldId="260"/>
            <ac:spMk id="11" creationId="{794771D6-337C-99CE-6C34-D8470C52B5F2}"/>
          </ac:spMkLst>
        </pc:spChg>
        <pc:spChg chg="mod">
          <ac:chgData name="Dhakal, Alfa" userId="S::aldhakal@iu.edu::47175381-e0f0-42f2-a909-d585e2a70e98" providerId="AD" clId="Web-{9625A293-8E58-EC2E-1CF5-E2DAD4A02FC4}" dt="2024-01-22T20:37:17.752" v="282" actId="1076"/>
          <ac:spMkLst>
            <pc:docMk/>
            <pc:sldMk cId="2638478859" sldId="260"/>
            <ac:spMk id="12" creationId="{3CB3252D-2B19-B3FB-2EBB-B77BA76FD202}"/>
          </ac:spMkLst>
        </pc:spChg>
        <pc:spChg chg="mod">
          <ac:chgData name="Dhakal, Alfa" userId="S::aldhakal@iu.edu::47175381-e0f0-42f2-a909-d585e2a70e98" providerId="AD" clId="Web-{9625A293-8E58-EC2E-1CF5-E2DAD4A02FC4}" dt="2024-01-22T20:37:11.127" v="273" actId="1076"/>
          <ac:spMkLst>
            <pc:docMk/>
            <pc:sldMk cId="2638478859" sldId="260"/>
            <ac:spMk id="14" creationId="{1AB6414B-041A-2875-8ADC-9D0CE77E1F81}"/>
          </ac:spMkLst>
        </pc:spChg>
        <pc:spChg chg="mod">
          <ac:chgData name="Dhakal, Alfa" userId="S::aldhakal@iu.edu::47175381-e0f0-42f2-a909-d585e2a70e98" providerId="AD" clId="Web-{9625A293-8E58-EC2E-1CF5-E2DAD4A02FC4}" dt="2024-01-22T20:37:11.143" v="274" actId="1076"/>
          <ac:spMkLst>
            <pc:docMk/>
            <pc:sldMk cId="2638478859" sldId="260"/>
            <ac:spMk id="15" creationId="{29C15E24-184C-4A87-BD1D-9B0760C14B92}"/>
          </ac:spMkLst>
        </pc:spChg>
        <pc:spChg chg="mod">
          <ac:chgData name="Dhakal, Alfa" userId="S::aldhakal@iu.edu::47175381-e0f0-42f2-a909-d585e2a70e98" providerId="AD" clId="Web-{9625A293-8E58-EC2E-1CF5-E2DAD4A02FC4}" dt="2024-01-22T20:37:11.158" v="275" actId="1076"/>
          <ac:spMkLst>
            <pc:docMk/>
            <pc:sldMk cId="2638478859" sldId="260"/>
            <ac:spMk id="16" creationId="{1284BDEA-2FB6-AD92-F9F5-E7F9BBEF31AE}"/>
          </ac:spMkLst>
        </pc:spChg>
        <pc:spChg chg="mod">
          <ac:chgData name="Dhakal, Alfa" userId="S::aldhakal@iu.edu::47175381-e0f0-42f2-a909-d585e2a70e98" providerId="AD" clId="Web-{9625A293-8E58-EC2E-1CF5-E2DAD4A02FC4}" dt="2024-01-22T20:37:11.174" v="276" actId="1076"/>
          <ac:spMkLst>
            <pc:docMk/>
            <pc:sldMk cId="2638478859" sldId="260"/>
            <ac:spMk id="17" creationId="{4C01EF2A-EA32-E507-39AE-0E932C71C9D7}"/>
          </ac:spMkLst>
        </pc:spChg>
        <pc:spChg chg="mod">
          <ac:chgData name="Dhakal, Alfa" userId="S::aldhakal@iu.edu::47175381-e0f0-42f2-a909-d585e2a70e98" providerId="AD" clId="Web-{9625A293-8E58-EC2E-1CF5-E2DAD4A02FC4}" dt="2024-01-22T20:37:11.174" v="277" actId="1076"/>
          <ac:spMkLst>
            <pc:docMk/>
            <pc:sldMk cId="2638478859" sldId="260"/>
            <ac:spMk id="18" creationId="{BD4EE89E-D90C-2D8B-2601-041298795C8F}"/>
          </ac:spMkLst>
        </pc:spChg>
        <pc:spChg chg="mod">
          <ac:chgData name="Dhakal, Alfa" userId="S::aldhakal@iu.edu::47175381-e0f0-42f2-a909-d585e2a70e98" providerId="AD" clId="Web-{9625A293-8E58-EC2E-1CF5-E2DAD4A02FC4}" dt="2024-01-22T20:37:11.190" v="278" actId="1076"/>
          <ac:spMkLst>
            <pc:docMk/>
            <pc:sldMk cId="2638478859" sldId="260"/>
            <ac:spMk id="19" creationId="{807092C7-3CDA-33E1-79C7-0357E380FD5A}"/>
          </ac:spMkLst>
        </pc:spChg>
        <pc:spChg chg="mod">
          <ac:chgData name="Dhakal, Alfa" userId="S::aldhakal@iu.edu::47175381-e0f0-42f2-a909-d585e2a70e98" providerId="AD" clId="Web-{9625A293-8E58-EC2E-1CF5-E2DAD4A02FC4}" dt="2024-01-22T20:37:11.205" v="279" actId="1076"/>
          <ac:spMkLst>
            <pc:docMk/>
            <pc:sldMk cId="2638478859" sldId="260"/>
            <ac:spMk id="20" creationId="{B9E41176-87FB-517B-B426-BB4D118CAB73}"/>
          </ac:spMkLst>
        </pc:spChg>
        <pc:spChg chg="mod">
          <ac:chgData name="Dhakal, Alfa" userId="S::aldhakal@iu.edu::47175381-e0f0-42f2-a909-d585e2a70e98" providerId="AD" clId="Web-{9625A293-8E58-EC2E-1CF5-E2DAD4A02FC4}" dt="2024-01-22T20:37:11.205" v="280" actId="1076"/>
          <ac:spMkLst>
            <pc:docMk/>
            <pc:sldMk cId="2638478859" sldId="260"/>
            <ac:spMk id="21" creationId="{3F997296-F0D8-B55C-3F14-3B31C10E43D8}"/>
          </ac:spMkLst>
        </pc:spChg>
        <pc:picChg chg="mod">
          <ac:chgData name="Dhakal, Alfa" userId="S::aldhakal@iu.edu::47175381-e0f0-42f2-a909-d585e2a70e98" providerId="AD" clId="Web-{9625A293-8E58-EC2E-1CF5-E2DAD4A02FC4}" dt="2024-01-22T20:37:56.644" v="287" actId="1076"/>
          <ac:picMkLst>
            <pc:docMk/>
            <pc:sldMk cId="2638478859" sldId="260"/>
            <ac:picMk id="10" creationId="{28688B6E-E1B9-EAD8-1892-625A0D32E3CB}"/>
          </ac:picMkLst>
        </pc:picChg>
        <pc:picChg chg="mod">
          <ac:chgData name="Dhakal, Alfa" userId="S::aldhakal@iu.edu::47175381-e0f0-42f2-a909-d585e2a70e98" providerId="AD" clId="Web-{9625A293-8E58-EC2E-1CF5-E2DAD4A02FC4}" dt="2024-01-22T20:37:47.159" v="286" actId="14100"/>
          <ac:picMkLst>
            <pc:docMk/>
            <pc:sldMk cId="2638478859" sldId="260"/>
            <ac:picMk id="13" creationId="{D712C09F-2C31-753C-190D-420686C7E793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77DE9-0DBB-6044-A1C4-EE580710CA51}" type="datetimeFigureOut">
              <a:rPr lang="en-US" smtClean="0"/>
              <a:t>1/2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9DE145-0AE8-4148-9CF9-CE5ADE22CE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2338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77DE9-0DBB-6044-A1C4-EE580710CA51}" type="datetimeFigureOut">
              <a:rPr lang="en-US" smtClean="0"/>
              <a:t>1/2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9DE145-0AE8-4148-9CF9-CE5ADE22CE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61191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77DE9-0DBB-6044-A1C4-EE580710CA51}" type="datetimeFigureOut">
              <a:rPr lang="en-US" smtClean="0"/>
              <a:t>1/2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9DE145-0AE8-4148-9CF9-CE5ADE22CE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96879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77DE9-0DBB-6044-A1C4-EE580710CA51}" type="datetimeFigureOut">
              <a:rPr lang="en-US" smtClean="0"/>
              <a:t>1/2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9DE145-0AE8-4148-9CF9-CE5ADE22CE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92793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77DE9-0DBB-6044-A1C4-EE580710CA51}" type="datetimeFigureOut">
              <a:rPr lang="en-US" smtClean="0"/>
              <a:t>1/2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9DE145-0AE8-4148-9CF9-CE5ADE22CE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24126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77DE9-0DBB-6044-A1C4-EE580710CA51}" type="datetimeFigureOut">
              <a:rPr lang="en-US" smtClean="0"/>
              <a:t>1/2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9DE145-0AE8-4148-9CF9-CE5ADE22CE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50308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77DE9-0DBB-6044-A1C4-EE580710CA51}" type="datetimeFigureOut">
              <a:rPr lang="en-US" smtClean="0"/>
              <a:t>1/24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9DE145-0AE8-4148-9CF9-CE5ADE22CE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3775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77DE9-0DBB-6044-A1C4-EE580710CA51}" type="datetimeFigureOut">
              <a:rPr lang="en-US" smtClean="0"/>
              <a:t>1/24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9DE145-0AE8-4148-9CF9-CE5ADE22CE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88365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77DE9-0DBB-6044-A1C4-EE580710CA51}" type="datetimeFigureOut">
              <a:rPr lang="en-US" smtClean="0"/>
              <a:t>1/24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9DE145-0AE8-4148-9CF9-CE5ADE22CE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96705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77DE9-0DBB-6044-A1C4-EE580710CA51}" type="datetimeFigureOut">
              <a:rPr lang="en-US" smtClean="0"/>
              <a:t>1/2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9DE145-0AE8-4148-9CF9-CE5ADE22CE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05442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77DE9-0DBB-6044-A1C4-EE580710CA51}" type="datetimeFigureOut">
              <a:rPr lang="en-US" smtClean="0"/>
              <a:t>1/2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9DE145-0AE8-4148-9CF9-CE5ADE22CE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31389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077DE9-0DBB-6044-A1C4-EE580710CA51}" type="datetimeFigureOut">
              <a:rPr lang="en-US" smtClean="0"/>
              <a:t>1/2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9DE145-0AE8-4148-9CF9-CE5ADE22CE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93265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Rectangle 15">
            <a:extLst>
              <a:ext uri="{FF2B5EF4-FFF2-40B4-BE49-F238E27FC236}">
                <a16:creationId xmlns:a16="http://schemas.microsoft.com/office/drawing/2014/main" id="{DFFDA3E1-CC0A-D8EE-04F1-D55252392549}"/>
              </a:ext>
            </a:extLst>
          </p:cNvPr>
          <p:cNvSpPr/>
          <p:nvPr/>
        </p:nvSpPr>
        <p:spPr>
          <a:xfrm>
            <a:off x="446131" y="2677705"/>
            <a:ext cx="3783731" cy="169980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4B258552-E4E7-E0F9-218E-CAB66E9E48A6}"/>
              </a:ext>
            </a:extLst>
          </p:cNvPr>
          <p:cNvSpPr txBox="1"/>
          <p:nvPr/>
        </p:nvSpPr>
        <p:spPr>
          <a:xfrm>
            <a:off x="52694" y="1743997"/>
            <a:ext cx="7500481" cy="83099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200" dirty="0">
                <a:latin typeface="Arial"/>
                <a:cs typeface="Arial"/>
              </a:rPr>
              <a:t>Anti-V5 Antibody</a:t>
            </a:r>
          </a:p>
          <a:p>
            <a:r>
              <a:rPr lang="en-US" sz="1200" dirty="0">
                <a:latin typeface="Arial"/>
                <a:cs typeface="Arial"/>
              </a:rPr>
              <a:t> </a:t>
            </a:r>
          </a:p>
          <a:p>
            <a:r>
              <a:rPr lang="en-US" sz="1200" dirty="0">
                <a:latin typeface="Arial"/>
                <a:cs typeface="Arial"/>
              </a:rPr>
              <a:t>OP50              +      -       +      -        +       -                                                                 +        -</a:t>
            </a:r>
          </a:p>
          <a:p>
            <a:r>
              <a:rPr lang="en-US" sz="1200" dirty="0">
                <a:latin typeface="Arial"/>
                <a:cs typeface="Arial"/>
              </a:rPr>
              <a:t>PA14               -      +       -      +        -       +                                                                 -        +</a:t>
            </a:r>
          </a:p>
        </p:txBody>
      </p:sp>
      <p:pic>
        <p:nvPicPr>
          <p:cNvPr id="27" name="Picture 26">
            <a:extLst>
              <a:ext uri="{FF2B5EF4-FFF2-40B4-BE49-F238E27FC236}">
                <a16:creationId xmlns:a16="http://schemas.microsoft.com/office/drawing/2014/main" id="{D4934E7A-40E6-E538-3B11-AD610ECC7D6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3088" y="2684638"/>
            <a:ext cx="3687734" cy="1552317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412B5CA8-1100-0C67-528B-D2B2B6A131B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35404" y="2692805"/>
            <a:ext cx="3285661" cy="1593776"/>
          </a:xfrm>
          <a:prstGeom prst="rect">
            <a:avLst/>
          </a:prstGeom>
        </p:spPr>
      </p:pic>
      <p:sp>
        <p:nvSpPr>
          <p:cNvPr id="35" name="Left Brace 34">
            <a:extLst>
              <a:ext uri="{FF2B5EF4-FFF2-40B4-BE49-F238E27FC236}">
                <a16:creationId xmlns:a16="http://schemas.microsoft.com/office/drawing/2014/main" id="{CC0098FA-2F1B-0698-E55F-5299F3A59073}"/>
              </a:ext>
            </a:extLst>
          </p:cNvPr>
          <p:cNvSpPr/>
          <p:nvPr/>
        </p:nvSpPr>
        <p:spPr>
          <a:xfrm rot="5400000" flipH="1">
            <a:off x="1262275" y="4276922"/>
            <a:ext cx="335604" cy="677333"/>
          </a:xfrm>
          <a:prstGeom prst="leftBrac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Left Brace 35">
            <a:extLst>
              <a:ext uri="{FF2B5EF4-FFF2-40B4-BE49-F238E27FC236}">
                <a16:creationId xmlns:a16="http://schemas.microsoft.com/office/drawing/2014/main" id="{AA477702-B834-DC7F-7B34-4CC449F50D92}"/>
              </a:ext>
            </a:extLst>
          </p:cNvPr>
          <p:cNvSpPr/>
          <p:nvPr/>
        </p:nvSpPr>
        <p:spPr>
          <a:xfrm rot="5400000" flipH="1">
            <a:off x="2058992" y="4276923"/>
            <a:ext cx="344241" cy="677333"/>
          </a:xfrm>
          <a:prstGeom prst="leftBrace">
            <a:avLst>
              <a:gd name="adj1" fmla="val 8333"/>
              <a:gd name="adj2" fmla="val 47500"/>
            </a:avLst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7" name="Left Brace 36">
            <a:extLst>
              <a:ext uri="{FF2B5EF4-FFF2-40B4-BE49-F238E27FC236}">
                <a16:creationId xmlns:a16="http://schemas.microsoft.com/office/drawing/2014/main" id="{98D814D5-7DC1-C0C3-14FD-4FD02BEB4A43}"/>
              </a:ext>
            </a:extLst>
          </p:cNvPr>
          <p:cNvSpPr/>
          <p:nvPr/>
        </p:nvSpPr>
        <p:spPr>
          <a:xfrm rot="5400000" flipH="1">
            <a:off x="2852403" y="4284548"/>
            <a:ext cx="359489" cy="677333"/>
          </a:xfrm>
          <a:prstGeom prst="leftBrace">
            <a:avLst>
              <a:gd name="adj1" fmla="val 8333"/>
              <a:gd name="adj2" fmla="val 47500"/>
            </a:avLst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Left Brace 37">
            <a:extLst>
              <a:ext uri="{FF2B5EF4-FFF2-40B4-BE49-F238E27FC236}">
                <a16:creationId xmlns:a16="http://schemas.microsoft.com/office/drawing/2014/main" id="{2FB9963A-3093-52D9-C122-F05A9D94A96D}"/>
              </a:ext>
            </a:extLst>
          </p:cNvPr>
          <p:cNvSpPr/>
          <p:nvPr/>
        </p:nvSpPr>
        <p:spPr>
          <a:xfrm rot="5400000" flipH="1">
            <a:off x="5953868" y="4013491"/>
            <a:ext cx="279412" cy="1139703"/>
          </a:xfrm>
          <a:prstGeom prst="leftBrace">
            <a:avLst>
              <a:gd name="adj1" fmla="val 8333"/>
              <a:gd name="adj2" fmla="val 47500"/>
            </a:avLst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4E2E7A56-DF44-DCAA-AC83-8E157431ACB9}"/>
              </a:ext>
            </a:extLst>
          </p:cNvPr>
          <p:cNvSpPr txBox="1"/>
          <p:nvPr/>
        </p:nvSpPr>
        <p:spPr>
          <a:xfrm>
            <a:off x="1108820" y="4802958"/>
            <a:ext cx="5501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/>
                <a:cs typeface="Arial"/>
              </a:rPr>
              <a:t>Rep1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870CC7AA-4DF4-BD8A-A0EF-B48333064E39}"/>
              </a:ext>
            </a:extLst>
          </p:cNvPr>
          <p:cNvSpPr txBox="1"/>
          <p:nvPr/>
        </p:nvSpPr>
        <p:spPr>
          <a:xfrm>
            <a:off x="1904681" y="4802958"/>
            <a:ext cx="5501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/>
                <a:cs typeface="Arial"/>
              </a:rPr>
              <a:t>Rep2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AC052E2E-ED8B-E5B5-F216-EB39CDDB2983}"/>
              </a:ext>
            </a:extLst>
          </p:cNvPr>
          <p:cNvSpPr txBox="1"/>
          <p:nvPr/>
        </p:nvSpPr>
        <p:spPr>
          <a:xfrm>
            <a:off x="2677520" y="4802958"/>
            <a:ext cx="5501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/>
                <a:cs typeface="Arial"/>
              </a:rPr>
              <a:t>Rep3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878FD294-2F41-4BD5-2698-4BEE098949B4}"/>
              </a:ext>
            </a:extLst>
          </p:cNvPr>
          <p:cNvSpPr txBox="1"/>
          <p:nvPr/>
        </p:nvSpPr>
        <p:spPr>
          <a:xfrm>
            <a:off x="5816306" y="4728613"/>
            <a:ext cx="5501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/>
                <a:cs typeface="Arial"/>
              </a:rPr>
              <a:t>Rep4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7B4260B-17F8-0043-69EC-7CFAFB13CE1A}"/>
              </a:ext>
            </a:extLst>
          </p:cNvPr>
          <p:cNvSpPr txBox="1"/>
          <p:nvPr/>
        </p:nvSpPr>
        <p:spPr>
          <a:xfrm>
            <a:off x="-35163" y="3703480"/>
            <a:ext cx="591518" cy="461665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latin typeface="Arial"/>
                <a:cs typeface="Arial"/>
              </a:rPr>
              <a:t>110 </a:t>
            </a:r>
            <a:r>
              <a:rPr lang="en-US" sz="1200" dirty="0" err="1">
                <a:latin typeface="Arial"/>
                <a:cs typeface="Arial"/>
              </a:rPr>
              <a:t>KDa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8497AB2-100A-8C97-D4A1-1D8382D5480C}"/>
              </a:ext>
            </a:extLst>
          </p:cNvPr>
          <p:cNvSpPr txBox="1"/>
          <p:nvPr/>
        </p:nvSpPr>
        <p:spPr>
          <a:xfrm>
            <a:off x="115746" y="82275"/>
            <a:ext cx="7384734" cy="138499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200" b="1" dirty="0">
                <a:latin typeface="Arial"/>
                <a:cs typeface="Arial"/>
              </a:rPr>
              <a:t>Additional file 6: Fig. S6. ADR-1 protein expression increases upon </a:t>
            </a:r>
            <a:r>
              <a:rPr lang="en-US" sz="1200" b="1" i="1" dirty="0">
                <a:latin typeface="Arial"/>
                <a:cs typeface="Arial"/>
              </a:rPr>
              <a:t>P. aeruginosa</a:t>
            </a:r>
            <a:r>
              <a:rPr lang="en-US" sz="1200" b="1" dirty="0">
                <a:latin typeface="Arial"/>
                <a:cs typeface="Arial"/>
              </a:rPr>
              <a:t> (PA14) exposure (Uncropped images for Figure 2). </a:t>
            </a:r>
            <a:r>
              <a:rPr lang="en-US" sz="1200" b="0" dirty="0">
                <a:solidFill>
                  <a:srgbClr val="1D1C1D"/>
                </a:solidFill>
                <a:effectLst/>
                <a:latin typeface="Arial"/>
                <a:cs typeface="Arial"/>
              </a:rPr>
              <a:t>To minimize inaccuracies from stripping and </a:t>
            </a:r>
            <a:r>
              <a:rPr lang="en-US" sz="1200" b="0" dirty="0" err="1">
                <a:solidFill>
                  <a:srgbClr val="1D1C1D"/>
                </a:solidFill>
                <a:effectLst/>
                <a:latin typeface="Arial"/>
                <a:cs typeface="Arial"/>
              </a:rPr>
              <a:t>reprobing</a:t>
            </a:r>
            <a:r>
              <a:rPr lang="en-US" sz="1200" b="0" dirty="0">
                <a:solidFill>
                  <a:srgbClr val="1D1C1D"/>
                </a:solidFill>
                <a:effectLst/>
                <a:latin typeface="Arial"/>
                <a:cs typeface="Arial"/>
              </a:rPr>
              <a:t> immunoblots, blots were cut into three pieces to allow for simultaneous probing of loading controls and proteins of interest.</a:t>
            </a:r>
            <a:r>
              <a:rPr lang="en-US" sz="1200" b="1" dirty="0">
                <a:latin typeface="Arial"/>
                <a:cs typeface="Arial"/>
              </a:rPr>
              <a:t> </a:t>
            </a:r>
            <a:r>
              <a:rPr lang="en-US" sz="1200" dirty="0">
                <a:effectLst/>
                <a:latin typeface="Arial"/>
                <a:cs typeface="Arial"/>
              </a:rPr>
              <a:t>Images were taken on the </a:t>
            </a:r>
            <a:r>
              <a:rPr lang="en-US" sz="1200" dirty="0" err="1">
                <a:effectLst/>
                <a:latin typeface="Arial"/>
                <a:cs typeface="Arial"/>
              </a:rPr>
              <a:t>ImageLab</a:t>
            </a:r>
            <a:r>
              <a:rPr lang="en-US" sz="1200" dirty="0">
                <a:effectLst/>
                <a:latin typeface="Arial"/>
                <a:cs typeface="Arial"/>
              </a:rPr>
              <a:t> 6.1 software using the Bio-Rad </a:t>
            </a:r>
            <a:r>
              <a:rPr lang="en-US" sz="1200" dirty="0" err="1">
                <a:effectLst/>
                <a:latin typeface="Arial"/>
                <a:cs typeface="Arial"/>
              </a:rPr>
              <a:t>Chemidoc</a:t>
            </a:r>
            <a:r>
              <a:rPr lang="en-US" sz="1200" dirty="0">
                <a:effectLst/>
                <a:latin typeface="Arial"/>
                <a:cs typeface="Arial"/>
              </a:rPr>
              <a:t> MP. Imaging was done using Chemi Hi Sensitivity. The blots for ADR-1 are after 1 second exposure. The blots for ADR-2 and Actin are after 4 seconds exposure.</a:t>
            </a:r>
            <a:r>
              <a:rPr lang="en-US" sz="1200" dirty="0">
                <a:latin typeface="Arial"/>
                <a:cs typeface="Arial"/>
              </a:rPr>
              <a:t> The region of the blot that is cropped and used in Figure 2D is marked with a red box. </a:t>
            </a:r>
            <a:endParaRPr lang="en-US" sz="1200" dirty="0">
              <a:effectLst/>
              <a:latin typeface="Arial"/>
              <a:cs typeface="Calibri"/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9D4448E8-C797-2581-ABFC-38FAE1311E09}"/>
              </a:ext>
            </a:extLst>
          </p:cNvPr>
          <p:cNvSpPr/>
          <p:nvPr/>
        </p:nvSpPr>
        <p:spPr>
          <a:xfrm>
            <a:off x="437350" y="6528737"/>
            <a:ext cx="3880490" cy="1554703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E9D6EB2C-8558-12C0-5628-863A2E700FD6}"/>
              </a:ext>
            </a:extLst>
          </p:cNvPr>
          <p:cNvSpPr/>
          <p:nvPr/>
        </p:nvSpPr>
        <p:spPr>
          <a:xfrm>
            <a:off x="4396697" y="6528738"/>
            <a:ext cx="3152398" cy="1554703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88C60C91-89C4-88A4-C654-00AE1985E2E4}"/>
              </a:ext>
            </a:extLst>
          </p:cNvPr>
          <p:cNvSpPr/>
          <p:nvPr/>
        </p:nvSpPr>
        <p:spPr>
          <a:xfrm>
            <a:off x="4313606" y="2704058"/>
            <a:ext cx="3307460" cy="16679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98DB1695-CB74-28ED-DC68-5C7EE98B0F94}"/>
              </a:ext>
            </a:extLst>
          </p:cNvPr>
          <p:cNvSpPr txBox="1"/>
          <p:nvPr/>
        </p:nvSpPr>
        <p:spPr>
          <a:xfrm>
            <a:off x="-1" y="5437690"/>
            <a:ext cx="7500481" cy="83099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200" dirty="0">
                <a:latin typeface="Arial"/>
                <a:cs typeface="Arial"/>
              </a:rPr>
              <a:t>Anti-FLAG Antibody</a:t>
            </a:r>
          </a:p>
          <a:p>
            <a:r>
              <a:rPr lang="en-US" sz="1200" dirty="0">
                <a:latin typeface="Arial"/>
                <a:cs typeface="Arial"/>
              </a:rPr>
              <a:t> </a:t>
            </a:r>
          </a:p>
          <a:p>
            <a:r>
              <a:rPr lang="en-US" sz="1200" dirty="0">
                <a:latin typeface="Arial"/>
                <a:cs typeface="Arial"/>
              </a:rPr>
              <a:t>OP50            +       -       +      -        +       -                                                                 +         -</a:t>
            </a:r>
          </a:p>
          <a:p>
            <a:r>
              <a:rPr lang="en-US" sz="1200" dirty="0">
                <a:latin typeface="Arial"/>
                <a:cs typeface="Arial"/>
              </a:rPr>
              <a:t>PA14             -       +       -      +        -       +                                                                 -         +</a:t>
            </a:r>
          </a:p>
        </p:txBody>
      </p:sp>
      <p:pic>
        <p:nvPicPr>
          <p:cNvPr id="31" name="Picture 30">
            <a:extLst>
              <a:ext uri="{FF2B5EF4-FFF2-40B4-BE49-F238E27FC236}">
                <a16:creationId xmlns:a16="http://schemas.microsoft.com/office/drawing/2014/main" id="{40FF6DC3-C336-FF14-4C19-D8B6DA3F4EC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447785" y="6599014"/>
            <a:ext cx="3052695" cy="1466857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FE8E8AD3-79B4-28A0-D17A-F408F17C9EC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4914" y="6532603"/>
            <a:ext cx="3849909" cy="1542053"/>
          </a:xfrm>
          <a:prstGeom prst="rect">
            <a:avLst/>
          </a:prstGeom>
        </p:spPr>
      </p:pic>
      <p:sp>
        <p:nvSpPr>
          <p:cNvPr id="43" name="Left Brace 42">
            <a:extLst>
              <a:ext uri="{FF2B5EF4-FFF2-40B4-BE49-F238E27FC236}">
                <a16:creationId xmlns:a16="http://schemas.microsoft.com/office/drawing/2014/main" id="{99ED0230-8BD9-AA56-7CFD-DCC78AB3DB3A}"/>
              </a:ext>
            </a:extLst>
          </p:cNvPr>
          <p:cNvSpPr/>
          <p:nvPr/>
        </p:nvSpPr>
        <p:spPr>
          <a:xfrm rot="5400000" flipH="1">
            <a:off x="1131795" y="7963213"/>
            <a:ext cx="335604" cy="677333"/>
          </a:xfrm>
          <a:prstGeom prst="leftBrac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Left Brace 43">
            <a:extLst>
              <a:ext uri="{FF2B5EF4-FFF2-40B4-BE49-F238E27FC236}">
                <a16:creationId xmlns:a16="http://schemas.microsoft.com/office/drawing/2014/main" id="{063B6C53-55F5-1D6F-09CE-A4619C20ACE5}"/>
              </a:ext>
            </a:extLst>
          </p:cNvPr>
          <p:cNvSpPr/>
          <p:nvPr/>
        </p:nvSpPr>
        <p:spPr>
          <a:xfrm rot="5400000" flipH="1">
            <a:off x="1928512" y="7963214"/>
            <a:ext cx="344241" cy="677333"/>
          </a:xfrm>
          <a:prstGeom prst="leftBrace">
            <a:avLst>
              <a:gd name="adj1" fmla="val 8333"/>
              <a:gd name="adj2" fmla="val 47500"/>
            </a:avLst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5" name="Left Brace 44">
            <a:extLst>
              <a:ext uri="{FF2B5EF4-FFF2-40B4-BE49-F238E27FC236}">
                <a16:creationId xmlns:a16="http://schemas.microsoft.com/office/drawing/2014/main" id="{6427F8D4-7DF9-E801-A25F-915EA8438710}"/>
              </a:ext>
            </a:extLst>
          </p:cNvPr>
          <p:cNvSpPr/>
          <p:nvPr/>
        </p:nvSpPr>
        <p:spPr>
          <a:xfrm rot="5400000" flipH="1">
            <a:off x="2721923" y="7970839"/>
            <a:ext cx="359489" cy="677333"/>
          </a:xfrm>
          <a:prstGeom prst="leftBrace">
            <a:avLst>
              <a:gd name="adj1" fmla="val 8333"/>
              <a:gd name="adj2" fmla="val 47500"/>
            </a:avLst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Left Brace 45">
            <a:extLst>
              <a:ext uri="{FF2B5EF4-FFF2-40B4-BE49-F238E27FC236}">
                <a16:creationId xmlns:a16="http://schemas.microsoft.com/office/drawing/2014/main" id="{A6BA71D8-45C0-973E-AD3A-A8F9E8A5D6DB}"/>
              </a:ext>
            </a:extLst>
          </p:cNvPr>
          <p:cNvSpPr/>
          <p:nvPr/>
        </p:nvSpPr>
        <p:spPr>
          <a:xfrm rot="5400000" flipH="1">
            <a:off x="5870727" y="7724650"/>
            <a:ext cx="279412" cy="1139703"/>
          </a:xfrm>
          <a:prstGeom prst="leftBrace">
            <a:avLst>
              <a:gd name="adj1" fmla="val 8333"/>
              <a:gd name="adj2" fmla="val 47500"/>
            </a:avLst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371C5374-EA00-2A1C-D494-C476173E2D45}"/>
              </a:ext>
            </a:extLst>
          </p:cNvPr>
          <p:cNvSpPr txBox="1"/>
          <p:nvPr/>
        </p:nvSpPr>
        <p:spPr>
          <a:xfrm>
            <a:off x="978340" y="8489249"/>
            <a:ext cx="5501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/>
                <a:cs typeface="Arial"/>
              </a:rPr>
              <a:t>Rep1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6CD0D8D4-4FCD-FFE2-AF05-5BA7D5073D1E}"/>
              </a:ext>
            </a:extLst>
          </p:cNvPr>
          <p:cNvSpPr txBox="1"/>
          <p:nvPr/>
        </p:nvSpPr>
        <p:spPr>
          <a:xfrm>
            <a:off x="1774201" y="8489249"/>
            <a:ext cx="5501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/>
                <a:cs typeface="Arial"/>
              </a:rPr>
              <a:t>Rep2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530EA3BF-EB96-382D-D88E-29FF2CB58322}"/>
              </a:ext>
            </a:extLst>
          </p:cNvPr>
          <p:cNvSpPr txBox="1"/>
          <p:nvPr/>
        </p:nvSpPr>
        <p:spPr>
          <a:xfrm>
            <a:off x="2547040" y="8489249"/>
            <a:ext cx="5501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/>
                <a:cs typeface="Arial"/>
              </a:rPr>
              <a:t>Rep3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FE033502-093F-C72B-639C-6A47155326AF}"/>
              </a:ext>
            </a:extLst>
          </p:cNvPr>
          <p:cNvSpPr txBox="1"/>
          <p:nvPr/>
        </p:nvSpPr>
        <p:spPr>
          <a:xfrm>
            <a:off x="5680471" y="8498385"/>
            <a:ext cx="5501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/>
                <a:cs typeface="Arial"/>
              </a:rPr>
              <a:t>Rep4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81E7850-1F8F-1C9D-770A-5E75A6A5F618}"/>
              </a:ext>
            </a:extLst>
          </p:cNvPr>
          <p:cNvSpPr txBox="1"/>
          <p:nvPr/>
        </p:nvSpPr>
        <p:spPr>
          <a:xfrm>
            <a:off x="-35206" y="7503820"/>
            <a:ext cx="670559" cy="461665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latin typeface="Arial"/>
                <a:cs typeface="Arial"/>
              </a:rPr>
              <a:t>55 </a:t>
            </a:r>
            <a:r>
              <a:rPr lang="en-US" sz="1200" dirty="0" err="1">
                <a:latin typeface="Arial"/>
                <a:cs typeface="Arial"/>
              </a:rPr>
              <a:t>KDa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CBD19C46-A7C5-8C76-7B23-08C99CE64254}"/>
              </a:ext>
            </a:extLst>
          </p:cNvPr>
          <p:cNvSpPr/>
          <p:nvPr/>
        </p:nvSpPr>
        <p:spPr>
          <a:xfrm>
            <a:off x="5441760" y="3449875"/>
            <a:ext cx="1405540" cy="509508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25A2C2D1-DAC3-CBB7-33DD-202E7B744A79}"/>
              </a:ext>
            </a:extLst>
          </p:cNvPr>
          <p:cNvSpPr/>
          <p:nvPr/>
        </p:nvSpPr>
        <p:spPr>
          <a:xfrm>
            <a:off x="5249963" y="6990081"/>
            <a:ext cx="1405540" cy="509508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981426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7CD1207E-68EA-5EAC-F601-B97FF20DBEC0}"/>
              </a:ext>
            </a:extLst>
          </p:cNvPr>
          <p:cNvSpPr txBox="1"/>
          <p:nvPr/>
        </p:nvSpPr>
        <p:spPr>
          <a:xfrm>
            <a:off x="0" y="1836597"/>
            <a:ext cx="7500481" cy="83099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200" dirty="0">
                <a:latin typeface="Arial"/>
                <a:cs typeface="Arial"/>
              </a:rPr>
              <a:t>Anti-Actin Antibody</a:t>
            </a:r>
          </a:p>
          <a:p>
            <a:r>
              <a:rPr lang="en-US" sz="1200" dirty="0">
                <a:latin typeface="Arial"/>
                <a:cs typeface="Arial"/>
              </a:rPr>
              <a:t> </a:t>
            </a:r>
          </a:p>
          <a:p>
            <a:r>
              <a:rPr lang="en-US" sz="1200" dirty="0">
                <a:latin typeface="Arial"/>
                <a:cs typeface="Arial"/>
              </a:rPr>
              <a:t>OP50         +       -        +        -        +         -                                                            +          -</a:t>
            </a:r>
          </a:p>
          <a:p>
            <a:r>
              <a:rPr lang="en-US" sz="1200" dirty="0">
                <a:latin typeface="Arial"/>
                <a:cs typeface="Arial"/>
              </a:rPr>
              <a:t>PA14          -       +        -        +        -         +                                                            -          +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28688B6E-E1B9-EAD8-1892-625A0D32E3C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1066" y="2636260"/>
            <a:ext cx="3982146" cy="1612884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794771D6-337C-99CE-6C34-D8470C52B5F2}"/>
              </a:ext>
            </a:extLst>
          </p:cNvPr>
          <p:cNvSpPr/>
          <p:nvPr/>
        </p:nvSpPr>
        <p:spPr>
          <a:xfrm>
            <a:off x="4553172" y="2671398"/>
            <a:ext cx="3048001" cy="1554703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3CB3252D-2B19-B3FB-2EBB-B77BA76FD202}"/>
              </a:ext>
            </a:extLst>
          </p:cNvPr>
          <p:cNvSpPr/>
          <p:nvPr/>
        </p:nvSpPr>
        <p:spPr>
          <a:xfrm>
            <a:off x="491066" y="2671398"/>
            <a:ext cx="3982146" cy="1554703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D712C09F-2C31-753C-190D-420686C7E79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70735" y="2671399"/>
            <a:ext cx="2968960" cy="1554703"/>
          </a:xfrm>
          <a:prstGeom prst="rect">
            <a:avLst/>
          </a:prstGeom>
        </p:spPr>
      </p:pic>
      <p:sp>
        <p:nvSpPr>
          <p:cNvPr id="14" name="Left Brace 13">
            <a:extLst>
              <a:ext uri="{FF2B5EF4-FFF2-40B4-BE49-F238E27FC236}">
                <a16:creationId xmlns:a16="http://schemas.microsoft.com/office/drawing/2014/main" id="{1AB6414B-041A-2875-8ADC-9D0CE77E1F81}"/>
              </a:ext>
            </a:extLst>
          </p:cNvPr>
          <p:cNvSpPr/>
          <p:nvPr/>
        </p:nvSpPr>
        <p:spPr>
          <a:xfrm rot="5400000" flipH="1">
            <a:off x="1064062" y="4205581"/>
            <a:ext cx="335604" cy="677333"/>
          </a:xfrm>
          <a:prstGeom prst="leftBrac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Left Brace 14">
            <a:extLst>
              <a:ext uri="{FF2B5EF4-FFF2-40B4-BE49-F238E27FC236}">
                <a16:creationId xmlns:a16="http://schemas.microsoft.com/office/drawing/2014/main" id="{29C15E24-184C-4A87-BD1D-9B0760C14B92}"/>
              </a:ext>
            </a:extLst>
          </p:cNvPr>
          <p:cNvSpPr/>
          <p:nvPr/>
        </p:nvSpPr>
        <p:spPr>
          <a:xfrm rot="5400000" flipH="1">
            <a:off x="1860779" y="4205582"/>
            <a:ext cx="344241" cy="677333"/>
          </a:xfrm>
          <a:prstGeom prst="leftBrace">
            <a:avLst>
              <a:gd name="adj1" fmla="val 8333"/>
              <a:gd name="adj2" fmla="val 47500"/>
            </a:avLst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6" name="Left Brace 15">
            <a:extLst>
              <a:ext uri="{FF2B5EF4-FFF2-40B4-BE49-F238E27FC236}">
                <a16:creationId xmlns:a16="http://schemas.microsoft.com/office/drawing/2014/main" id="{1284BDEA-2FB6-AD92-F9F5-E7F9BBEF31AE}"/>
              </a:ext>
            </a:extLst>
          </p:cNvPr>
          <p:cNvSpPr/>
          <p:nvPr/>
        </p:nvSpPr>
        <p:spPr>
          <a:xfrm rot="5400000" flipH="1">
            <a:off x="2654190" y="4213208"/>
            <a:ext cx="359489" cy="677333"/>
          </a:xfrm>
          <a:prstGeom prst="leftBrace">
            <a:avLst>
              <a:gd name="adj1" fmla="val 8333"/>
              <a:gd name="adj2" fmla="val 47500"/>
            </a:avLst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Left Brace 16">
            <a:extLst>
              <a:ext uri="{FF2B5EF4-FFF2-40B4-BE49-F238E27FC236}">
                <a16:creationId xmlns:a16="http://schemas.microsoft.com/office/drawing/2014/main" id="{4C01EF2A-EA32-E507-39AE-0E932C71C9D7}"/>
              </a:ext>
            </a:extLst>
          </p:cNvPr>
          <p:cNvSpPr/>
          <p:nvPr/>
        </p:nvSpPr>
        <p:spPr>
          <a:xfrm rot="5400000" flipH="1">
            <a:off x="5938460" y="3974396"/>
            <a:ext cx="279412" cy="1139703"/>
          </a:xfrm>
          <a:prstGeom prst="leftBrace">
            <a:avLst>
              <a:gd name="adj1" fmla="val 8333"/>
              <a:gd name="adj2" fmla="val 47500"/>
            </a:avLst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D4EE89E-D90C-2D8B-2601-041298795C8F}"/>
              </a:ext>
            </a:extLst>
          </p:cNvPr>
          <p:cNvSpPr txBox="1"/>
          <p:nvPr/>
        </p:nvSpPr>
        <p:spPr>
          <a:xfrm>
            <a:off x="910607" y="4731618"/>
            <a:ext cx="5501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/>
                <a:cs typeface="Arial"/>
              </a:rPr>
              <a:t>Rep1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07092C7-3CDA-33E1-79C7-0357E380FD5A}"/>
              </a:ext>
            </a:extLst>
          </p:cNvPr>
          <p:cNvSpPr txBox="1"/>
          <p:nvPr/>
        </p:nvSpPr>
        <p:spPr>
          <a:xfrm>
            <a:off x="1706468" y="4731618"/>
            <a:ext cx="5501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/>
                <a:cs typeface="Arial"/>
              </a:rPr>
              <a:t>Rep2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9E41176-87FB-517B-B426-BB4D118CAB73}"/>
              </a:ext>
            </a:extLst>
          </p:cNvPr>
          <p:cNvSpPr txBox="1"/>
          <p:nvPr/>
        </p:nvSpPr>
        <p:spPr>
          <a:xfrm>
            <a:off x="2479307" y="4731618"/>
            <a:ext cx="5501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/>
                <a:cs typeface="Arial"/>
              </a:rPr>
              <a:t>Rep3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F997296-F0D8-B55C-3F14-3B31C10E43D8}"/>
              </a:ext>
            </a:extLst>
          </p:cNvPr>
          <p:cNvSpPr txBox="1"/>
          <p:nvPr/>
        </p:nvSpPr>
        <p:spPr>
          <a:xfrm>
            <a:off x="5748204" y="4774547"/>
            <a:ext cx="5501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/>
                <a:cs typeface="Arial"/>
              </a:rPr>
              <a:t>Rep4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21863C5-371E-4FE0-C1E5-A89C0A365DB3}"/>
              </a:ext>
            </a:extLst>
          </p:cNvPr>
          <p:cNvSpPr txBox="1"/>
          <p:nvPr/>
        </p:nvSpPr>
        <p:spPr>
          <a:xfrm>
            <a:off x="-52781" y="3536616"/>
            <a:ext cx="617865" cy="461665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latin typeface="Arial"/>
                <a:cs typeface="Arial"/>
              </a:rPr>
              <a:t>40 </a:t>
            </a:r>
            <a:r>
              <a:rPr lang="en-US" sz="1200" dirty="0" err="1">
                <a:latin typeface="Arial"/>
                <a:cs typeface="Arial"/>
              </a:rPr>
              <a:t>KDa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CA02BCCE-8911-C858-7B1A-5141E8451F5C}"/>
              </a:ext>
            </a:extLst>
          </p:cNvPr>
          <p:cNvSpPr/>
          <p:nvPr/>
        </p:nvSpPr>
        <p:spPr>
          <a:xfrm>
            <a:off x="5197269" y="3195121"/>
            <a:ext cx="1405540" cy="509508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384788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886</TotalTime>
  <Words>199</Words>
  <Application>Microsoft Office PowerPoint</Application>
  <PresentationFormat>Custom</PresentationFormat>
  <Paragraphs>28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hakal, Alfa</dc:creator>
  <cp:lastModifiedBy>Hundley, Heather Ann</cp:lastModifiedBy>
  <cp:revision>191</cp:revision>
  <cp:lastPrinted>2023-01-16T17:38:53Z</cp:lastPrinted>
  <dcterms:created xsi:type="dcterms:W3CDTF">2023-01-16T15:14:18Z</dcterms:created>
  <dcterms:modified xsi:type="dcterms:W3CDTF">2024-01-24T20:56:55Z</dcterms:modified>
</cp:coreProperties>
</file>